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128524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5" autoAdjust="0"/>
    <p:restoredTop sz="94660"/>
  </p:normalViewPr>
  <p:slideViewPr>
    <p:cSldViewPr snapToGrid="0">
      <p:cViewPr varScale="1">
        <p:scale>
          <a:sx n="78" d="100"/>
          <a:sy n="78" d="100"/>
        </p:scale>
        <p:origin x="10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06550" y="1122363"/>
            <a:ext cx="96393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6550" y="3602038"/>
            <a:ext cx="96393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979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364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97499" y="365125"/>
            <a:ext cx="2771299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3603" y="365125"/>
            <a:ext cx="8153241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45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962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6909" y="1709739"/>
            <a:ext cx="1108519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6909" y="4589464"/>
            <a:ext cx="1108519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437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3603" y="1825625"/>
            <a:ext cx="546227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6528" y="1825625"/>
            <a:ext cx="546227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542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5277" y="365126"/>
            <a:ext cx="11085195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5277" y="1681163"/>
            <a:ext cx="543716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5277" y="2505075"/>
            <a:ext cx="5437167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06528" y="1681163"/>
            <a:ext cx="54639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06528" y="2505075"/>
            <a:ext cx="5463944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716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196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067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5277" y="457200"/>
            <a:ext cx="414523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63944" y="987426"/>
            <a:ext cx="650652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5277" y="2057400"/>
            <a:ext cx="414523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668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5277" y="457200"/>
            <a:ext cx="414523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63944" y="987426"/>
            <a:ext cx="650652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5277" y="2057400"/>
            <a:ext cx="414523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713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3603" y="365126"/>
            <a:ext cx="1108519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3603" y="1825625"/>
            <a:ext cx="1108519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3603" y="6356351"/>
            <a:ext cx="289179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88D3E-91AB-412E-9E83-2B50E85FBD98}" type="datetimeFigureOut">
              <a:rPr kumimoji="1" lang="ja-JP" altLang="en-US" smtClean="0"/>
              <a:t>2018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57358" y="6356351"/>
            <a:ext cx="433768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77008" y="6356351"/>
            <a:ext cx="289179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BFBCB-88A2-4779-AEBB-1238BCD19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958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54" y="1046383"/>
            <a:ext cx="12753546" cy="3751417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0146317" y="4576515"/>
            <a:ext cx="8932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class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857430" y="4605598"/>
            <a:ext cx="8932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 g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789696" y="4605599"/>
            <a:ext cx="8932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 g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901260" y="2059664"/>
            <a:ext cx="691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lass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160805" y="2064947"/>
            <a:ext cx="691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lass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98854" y="479937"/>
            <a:ext cx="37451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303920" y="479937"/>
            <a:ext cx="37451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592855" y="479937"/>
            <a:ext cx="37451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8207227" y="2657233"/>
            <a:ext cx="8932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 g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367173" y="448889"/>
            <a:ext cx="9332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err="1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Koshihikari</a:t>
            </a:r>
            <a:endParaRPr lang="en-US" altLang="ja-JP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.58g</a:t>
            </a:r>
            <a:endParaRPr kumimoji="1"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363695" y="854183"/>
            <a:ext cx="11801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err="1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Yamadanishiki</a:t>
            </a:r>
            <a:endParaRPr kumimoji="1" lang="en-US" altLang="ja-JP" sz="1200" dirty="0" smtClean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  <a:p>
            <a:pPr algn="ctr"/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.15g</a:t>
            </a:r>
            <a:endParaRPr kumimoji="1"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cxnSp>
        <p:nvCxnSpPr>
          <p:cNvPr id="19" name="直線矢印コネクタ 18"/>
          <p:cNvCxnSpPr/>
          <p:nvPr/>
        </p:nvCxnSpPr>
        <p:spPr>
          <a:xfrm flipH="1">
            <a:off x="2787157" y="854183"/>
            <a:ext cx="10356" cy="38408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/>
          <p:nvPr/>
        </p:nvCxnSpPr>
        <p:spPr>
          <a:xfrm>
            <a:off x="2241224" y="1267356"/>
            <a:ext cx="0" cy="121516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9252252" y="211212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994316" y="169561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0742641" y="144189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1502134" y="854183"/>
            <a:ext cx="260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286113" y="5087247"/>
            <a:ext cx="1236074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: 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he histograms (A and B) and boxplot (C) for OPW of RILs from </a:t>
            </a:r>
            <a:r>
              <a:rPr lang="en-US" altLang="ja-JP" sz="1500" kern="1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Koshihikari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/</a:t>
            </a:r>
            <a:r>
              <a:rPr lang="en-US" altLang="ja-JP" sz="1500" kern="1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Yamadanishiki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in 2015. The histogram (B) and boxplot used 180 RILs homozygous at the nearest SNP markers of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and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. The 180 RILs were classified into four class; class1: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K and </a:t>
            </a:r>
            <a:r>
              <a:rPr lang="en-US" altLang="ja-JP" sz="1500" i="1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Y (45 lines), 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lass2: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Y and </a:t>
            </a:r>
            <a:r>
              <a:rPr lang="en-US" altLang="ja-JP" sz="1500" i="1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Y (44 lines), 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lass3: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K and </a:t>
            </a:r>
            <a:r>
              <a:rPr lang="en-US" altLang="ja-JP" sz="1500" i="1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K (40 lines) 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nd class 4: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Y and </a:t>
            </a:r>
            <a:r>
              <a:rPr lang="en-US" altLang="ja-JP" sz="1500" i="1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_K (51 lines). </a:t>
            </a:r>
            <a:endParaRPr lang="ja-JP" altLang="ja-JP" sz="1500" kern="100" dirty="0">
              <a:effectLst/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4686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5213" t="8741" r="3400" b="8415"/>
          <a:stretch/>
        </p:blipFill>
        <p:spPr>
          <a:xfrm>
            <a:off x="6573795" y="372890"/>
            <a:ext cx="5684108" cy="5152768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5960" t="9933" r="4516" b="9210"/>
          <a:stretch/>
        </p:blipFill>
        <p:spPr>
          <a:xfrm>
            <a:off x="647228" y="434674"/>
            <a:ext cx="5568221" cy="50292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 rot="16200000">
            <a:off x="-186720" y="2736888"/>
            <a:ext cx="122820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</a:t>
            </a:r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OPW (g)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5821194" y="2736888"/>
            <a:ext cx="122820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</a:t>
            </a:r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OPW (g)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780166" y="5525658"/>
            <a:ext cx="15446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</a:t>
            </a:r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ays to heading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913236" y="5525658"/>
            <a:ext cx="15446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</a:t>
            </a:r>
            <a:r>
              <a:rPr lang="en-US" altLang="ja-JP" sz="12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ays to heading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54924" y="5989744"/>
            <a:ext cx="1236074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2: Scatter plots between OPW and days to heading for RILs in 2014 (A) and 2015 (A). No significant correlations were observed with Kendall’s rank correlation both years (2014; tau 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= 0.065,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= 0.19 and 2015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; tau = -0.076, </a:t>
            </a:r>
            <a:r>
              <a:rPr lang="en-US" altLang="ja-JP" sz="1500" i="1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</a:t>
            </a:r>
            <a:r>
              <a:rPr lang="en-US" altLang="ja-JP" sz="1500" kern="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= 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0.13).</a:t>
            </a:r>
            <a:endParaRPr lang="ja-JP" altLang="ja-JP" sz="1500" kern="100" dirty="0">
              <a:effectLst/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64050" y="234390"/>
            <a:ext cx="60801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</a:t>
            </a:r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131290" y="225116"/>
            <a:ext cx="60801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  B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104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336522" y="738924"/>
            <a:ext cx="120181" cy="53837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3434058" y="738924"/>
            <a:ext cx="120181" cy="53837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3836683" y="738924"/>
            <a:ext cx="98843" cy="43971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3934219" y="738924"/>
            <a:ext cx="98843" cy="43971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4339455" y="738923"/>
            <a:ext cx="108860" cy="44813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4448315" y="738923"/>
            <a:ext cx="121920" cy="44813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889694" y="738923"/>
            <a:ext cx="104502" cy="43129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4987230" y="738923"/>
            <a:ext cx="104502" cy="43129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5451228" y="738922"/>
            <a:ext cx="114336" cy="363674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5548764" y="738922"/>
            <a:ext cx="114336" cy="363674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5999107" y="738923"/>
            <a:ext cx="115595" cy="37673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6100649" y="738923"/>
            <a:ext cx="98755" cy="37673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6556080" y="738922"/>
            <a:ext cx="105400" cy="35757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6661480" y="738922"/>
            <a:ext cx="117768" cy="35757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7115463" y="738923"/>
            <a:ext cx="97536" cy="337445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7212999" y="738923"/>
            <a:ext cx="97536" cy="337445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7632607" y="738921"/>
            <a:ext cx="104295" cy="28529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7730143" y="738921"/>
            <a:ext cx="104295" cy="28529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8179060" y="738923"/>
            <a:ext cx="102853" cy="28181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8276596" y="738923"/>
            <a:ext cx="102853" cy="28181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正方形/長方形 21"/>
          <p:cNvSpPr/>
          <p:nvPr/>
        </p:nvSpPr>
        <p:spPr>
          <a:xfrm>
            <a:off x="8721756" y="738921"/>
            <a:ext cx="105169" cy="35670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8819292" y="738921"/>
            <a:ext cx="105169" cy="35670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9268208" y="738923"/>
            <a:ext cx="97536" cy="329023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9365744" y="738923"/>
            <a:ext cx="97536" cy="329023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336407" y="4384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837660" y="4384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352391" y="4316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463290" y="4474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5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901453" y="44037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011999" y="4244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6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567223" y="42887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7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7656394" y="4419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9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7116702" y="4340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8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8129389" y="4474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0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8669737" y="4600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1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188452" y="4600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2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9269517" y="1765517"/>
            <a:ext cx="98879" cy="77759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7622015" y="3197707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11004506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8666532" y="3358206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8665023" y="3546820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正方形/長方形 41"/>
          <p:cNvSpPr/>
          <p:nvPr/>
        </p:nvSpPr>
        <p:spPr>
          <a:xfrm>
            <a:off x="9039681" y="3278906"/>
            <a:ext cx="8082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11</a:t>
            </a:r>
            <a:endParaRPr lang="ja-JP" altLang="en-US" sz="1200" i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5455996" y="2778936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07001934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5473214" y="3384255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07005234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4377273" y="3911260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05000868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4359402" y="4160820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05001022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cxnSp>
        <p:nvCxnSpPr>
          <p:cNvPr id="47" name="直線コネクタ 46"/>
          <p:cNvCxnSpPr/>
          <p:nvPr/>
        </p:nvCxnSpPr>
        <p:spPr>
          <a:xfrm>
            <a:off x="6514238" y="2934892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6499221" y="3546820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>
            <a:off x="5391590" y="4072523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5399135" y="4297351"/>
            <a:ext cx="3245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矢印コネクタ 50"/>
          <p:cNvCxnSpPr/>
          <p:nvPr/>
        </p:nvCxnSpPr>
        <p:spPr>
          <a:xfrm>
            <a:off x="9061789" y="3339401"/>
            <a:ext cx="0" cy="24728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/>
          <p:cNvCxnSpPr/>
          <p:nvPr/>
        </p:nvCxnSpPr>
        <p:spPr>
          <a:xfrm>
            <a:off x="6937917" y="2932822"/>
            <a:ext cx="0" cy="62424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矢印コネクタ 52"/>
          <p:cNvCxnSpPr/>
          <p:nvPr/>
        </p:nvCxnSpPr>
        <p:spPr>
          <a:xfrm>
            <a:off x="5791674" y="4059238"/>
            <a:ext cx="0" cy="255468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正方形/長方形 53"/>
          <p:cNvSpPr/>
          <p:nvPr/>
        </p:nvSpPr>
        <p:spPr>
          <a:xfrm>
            <a:off x="6916846" y="3076478"/>
            <a:ext cx="7232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7</a:t>
            </a:r>
            <a:endParaRPr lang="ja-JP" altLang="en-US" sz="1200" i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5" name="正方形/長方形 54"/>
          <p:cNvSpPr/>
          <p:nvPr/>
        </p:nvSpPr>
        <p:spPr>
          <a:xfrm>
            <a:off x="5799963" y="4006931"/>
            <a:ext cx="7232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qOPW5</a:t>
            </a:r>
            <a:endParaRPr lang="ja-JP" altLang="en-US" sz="1200" i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215697" y="138072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SSL5-5</a:t>
            </a:r>
            <a:endParaRPr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正方形/長方形 56"/>
          <p:cNvSpPr/>
          <p:nvPr/>
        </p:nvSpPr>
        <p:spPr>
          <a:xfrm>
            <a:off x="3840025" y="737028"/>
            <a:ext cx="92849" cy="4571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4346500" y="1327578"/>
            <a:ext cx="92849" cy="46543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9" name="正方形/長方形 58"/>
          <p:cNvSpPr/>
          <p:nvPr/>
        </p:nvSpPr>
        <p:spPr>
          <a:xfrm>
            <a:off x="5455542" y="787790"/>
            <a:ext cx="92849" cy="9788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0" name="正方形/長方形 59"/>
          <p:cNvSpPr/>
          <p:nvPr/>
        </p:nvSpPr>
        <p:spPr>
          <a:xfrm>
            <a:off x="5550734" y="787788"/>
            <a:ext cx="108632" cy="9789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1" name="正方形/長方形 60"/>
          <p:cNvSpPr/>
          <p:nvPr/>
        </p:nvSpPr>
        <p:spPr>
          <a:xfrm>
            <a:off x="5448265" y="4029159"/>
            <a:ext cx="108507" cy="34651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2" name="正方形/長方形 61"/>
          <p:cNvSpPr/>
          <p:nvPr/>
        </p:nvSpPr>
        <p:spPr>
          <a:xfrm>
            <a:off x="5551261" y="4029160"/>
            <a:ext cx="115133" cy="3465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8179530" y="3514766"/>
            <a:ext cx="92849" cy="4571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7632759" y="3407961"/>
            <a:ext cx="1034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a11005083</a:t>
            </a:r>
            <a:endParaRPr lang="ja-JP" altLang="en-US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9264913" y="731490"/>
            <a:ext cx="105648" cy="21855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9367909" y="731493"/>
            <a:ext cx="94062" cy="21856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3215697" y="6347482"/>
            <a:ext cx="4539498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</a:t>
            </a:r>
            <a:r>
              <a:rPr lang="en-US" altLang="ja-JP" sz="1500" kern="1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S3: Graphical genotype of CSSL5-5.</a:t>
            </a:r>
            <a:endParaRPr lang="ja-JP" altLang="ja-JP" sz="1500" kern="100" dirty="0">
              <a:effectLst/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5470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221</Words>
  <Application>Microsoft Office PowerPoint</Application>
  <PresentationFormat>ユーザー設定</PresentationFormat>
  <Paragraphs>4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da</dc:creator>
  <cp:lastModifiedBy>okada</cp:lastModifiedBy>
  <cp:revision>18</cp:revision>
  <dcterms:created xsi:type="dcterms:W3CDTF">2017-09-01T09:16:52Z</dcterms:created>
  <dcterms:modified xsi:type="dcterms:W3CDTF">2018-06-16T10:47:06Z</dcterms:modified>
</cp:coreProperties>
</file>